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224" y="4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B3FC73-7AC6-4A32-8C51-B8B9CB5269C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8AE52F9-A1A1-40F6-BAD4-E305BFF6EA1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5CE19C-2A77-4715-B7CF-8A94AF7F1F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9FBC5-F893-486F-B766-619C1D79BAE7}" type="datetimeFigureOut">
              <a:rPr lang="en-US" smtClean="0"/>
              <a:t>7/1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531E67-1D88-4F47-B817-192DDF1099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AEDB76-E8BF-4181-B55C-5877E44F46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CA30-8958-40C1-A509-5CBEEC69F6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33672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030D25-949A-4424-B490-A13F19D762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0341B42-BAC2-4D0D-8C3C-97A92E117CD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0B4B67-1E7A-4078-BC77-33206D8D8A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9FBC5-F893-486F-B766-619C1D79BAE7}" type="datetimeFigureOut">
              <a:rPr lang="en-US" smtClean="0"/>
              <a:t>7/1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D964A6-DAF7-4BDC-86AE-49F5DCFD2D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4FD0FC-D477-41BB-B8A1-BC1AE7DDE2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CA30-8958-40C1-A509-5CBEEC69F6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05616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8634071-AF3A-4BEC-83C0-586C13B01CF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0A0AC12-6FEE-4E4D-B278-3D2EFD17609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0A0475-72D6-47AA-8E67-46B974FB8E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9FBC5-F893-486F-B766-619C1D79BAE7}" type="datetimeFigureOut">
              <a:rPr lang="en-US" smtClean="0"/>
              <a:t>7/1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F5F570-E47E-4BFB-8EF6-1D537AEF77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9C51B5-9495-482E-8E80-0AFCC84105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CA30-8958-40C1-A509-5CBEEC69F6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84955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AA3CB8-05E2-401D-BE4D-C7E7D63949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5C2FB4-91B7-4566-A0C2-49383CE3C88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2BCA9B-B94A-4D5F-BF68-35C5756C63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9FBC5-F893-486F-B766-619C1D79BAE7}" type="datetimeFigureOut">
              <a:rPr lang="en-US" smtClean="0"/>
              <a:t>7/1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084FA6-079C-4570-9F56-7F492CF6A0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CEBDC8-B20A-4C8D-8130-A4D5A6FAA1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CA30-8958-40C1-A509-5CBEEC69F6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31389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5F4B70-CEBD-4F2C-9503-2DFB138E6D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D0796A7-3DB4-4C34-91E9-B358A73245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E2ED2C-A832-4942-ADB8-622CF60061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9FBC5-F893-486F-B766-619C1D79BAE7}" type="datetimeFigureOut">
              <a:rPr lang="en-US" smtClean="0"/>
              <a:t>7/1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8E6B51-1AAB-4A27-80BF-7F32255848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ADB296-5AD6-4421-AF8E-B373E08DA9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CA30-8958-40C1-A509-5CBEEC69F6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63321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710ADF-6846-4FF3-B5E8-9A756A48FF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9282B06-FFDA-428F-879B-13004A2C19E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45A04FD-14B9-43A9-8331-34659ED9DE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90668F4-1F87-42A2-A808-E6F38F3302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9FBC5-F893-486F-B766-619C1D79BAE7}" type="datetimeFigureOut">
              <a:rPr lang="en-US" smtClean="0"/>
              <a:t>7/15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32E6AC-BA9E-4BDE-95A6-6B27721B62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5AEC7C0-95AE-46F2-9238-0A6C49658E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CA30-8958-40C1-A509-5CBEEC69F6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05306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34B347-6579-4CC1-819F-010A4E034C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6C29168-7BC4-45FD-9435-5871848C58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13737D1-2CC1-4F46-A363-979B87E057D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FF4B77F-F7F8-4B73-8901-BBEFB9646D5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A552227-5D20-4499-A6AA-607C6828063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C3F7548-8813-4C51-BFDC-F10E6E9521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9FBC5-F893-486F-B766-619C1D79BAE7}" type="datetimeFigureOut">
              <a:rPr lang="en-US" smtClean="0"/>
              <a:t>7/15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540C7CD-51E9-4C44-A9E4-0C1F997FFA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E17C144-D77C-4115-9C1A-1106B55CAD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CA30-8958-40C1-A509-5CBEEC69F6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6215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B2B3F8-0FD4-43D6-9344-0EAEE2B7DD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C4806CA-4700-4B18-BA2F-1FED91836D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9FBC5-F893-486F-B766-619C1D79BAE7}" type="datetimeFigureOut">
              <a:rPr lang="en-US" smtClean="0"/>
              <a:t>7/15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9817F43-20BD-4257-8D79-E9CA0E9900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1D14C5C-CAAB-4AE4-B708-BEA0E4FA58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CA30-8958-40C1-A509-5CBEEC69F6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06839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C889354-CF13-4EDC-8502-D1382B7EF8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9FBC5-F893-486F-B766-619C1D79BAE7}" type="datetimeFigureOut">
              <a:rPr lang="en-US" smtClean="0"/>
              <a:t>7/15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6E500E9-F25D-4A9A-9365-59572C97F9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92BCE10-04FD-4A54-8E57-0512A51F1F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CA30-8958-40C1-A509-5CBEEC69F6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69774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6A43A0-1478-4F02-82C3-3D82CB30C8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4952D6-1391-481E-83C1-38ABF30712B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752FB66-DCC5-4503-BE7A-17719A3814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C0A926E-8492-4760-AADB-00988AC7E6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9FBC5-F893-486F-B766-619C1D79BAE7}" type="datetimeFigureOut">
              <a:rPr lang="en-US" smtClean="0"/>
              <a:t>7/15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692F31F-9C82-4D0A-8E28-EF1E114F48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3CE0822-4956-4F31-A875-681AAB0CE6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CA30-8958-40C1-A509-5CBEEC69F6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29296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6B546A-CB51-459B-BFA8-544EF335E4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6EBF533-17BB-45D5-92C8-1CD8AD0B717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C26923B-DAF8-4116-BD25-4EC99F69B9D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F3A1486-1846-4B42-8473-1F747AA1AB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9FBC5-F893-486F-B766-619C1D79BAE7}" type="datetimeFigureOut">
              <a:rPr lang="en-US" smtClean="0"/>
              <a:t>7/15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7292F19-C283-4F7C-94A1-71AD33DAEE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4B01865-8526-4C5E-A80A-37E2508FEF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CA30-8958-40C1-A509-5CBEEC69F6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04320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CED433B-BE27-4491-8F56-7FE33FD6EC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7BCD856-0C97-4635-AE97-8DEED7A5B3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FA94D0-F7EC-4DE6-8FC9-E5777458638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79FBC5-F893-486F-B766-619C1D79BAE7}" type="datetimeFigureOut">
              <a:rPr lang="en-US" smtClean="0"/>
              <a:t>7/1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4251AD-0149-47F9-8315-0F17B239455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119D92-B828-480A-9D4B-5CCED208812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5ACA30-8958-40C1-A509-5CBEEC69F6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40410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1A462911-8A8A-43FE-B393-1DB9F3A6719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2434" y="1927345"/>
            <a:ext cx="11321012" cy="407726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34D8028-2CEE-4185-AACA-9861F1AA5C4F}"/>
              </a:ext>
            </a:extLst>
          </p:cNvPr>
          <p:cNvSpPr txBox="1"/>
          <p:nvPr/>
        </p:nvSpPr>
        <p:spPr>
          <a:xfrm>
            <a:off x="2787915" y="1478541"/>
            <a:ext cx="1285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xp #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A30484E-E362-4F4F-A057-08B4060CF3F3}"/>
              </a:ext>
            </a:extLst>
          </p:cNvPr>
          <p:cNvSpPr txBox="1"/>
          <p:nvPr/>
        </p:nvSpPr>
        <p:spPr>
          <a:xfrm>
            <a:off x="7204202" y="1478541"/>
            <a:ext cx="1285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xp #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E46C7F8-A732-43FF-A5BB-41B5C95AFBB2}"/>
              </a:ext>
            </a:extLst>
          </p:cNvPr>
          <p:cNvSpPr txBox="1"/>
          <p:nvPr/>
        </p:nvSpPr>
        <p:spPr>
          <a:xfrm>
            <a:off x="10375" y="3398016"/>
            <a:ext cx="1285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cti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49CD8F8-CF48-4A95-9DB6-CAEBBC899E05}"/>
              </a:ext>
            </a:extLst>
          </p:cNvPr>
          <p:cNvSpPr txBox="1"/>
          <p:nvPr/>
        </p:nvSpPr>
        <p:spPr>
          <a:xfrm>
            <a:off x="0" y="3965980"/>
            <a:ext cx="1285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-p65</a:t>
            </a: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6024EC16-D159-430C-96B7-F9D33BA4D2A1}"/>
              </a:ext>
            </a:extLst>
          </p:cNvPr>
          <p:cNvGrpSpPr/>
          <p:nvPr/>
        </p:nvGrpSpPr>
        <p:grpSpPr>
          <a:xfrm>
            <a:off x="1546411" y="2760872"/>
            <a:ext cx="1839340" cy="668128"/>
            <a:chOff x="170686" y="2621302"/>
            <a:chExt cx="2309455" cy="668128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1C11165B-E4DE-4BB5-8BBC-03700F5D1421}"/>
                </a:ext>
              </a:extLst>
            </p:cNvPr>
            <p:cNvSpPr txBox="1"/>
            <p:nvPr/>
          </p:nvSpPr>
          <p:spPr>
            <a:xfrm>
              <a:off x="226830" y="2881810"/>
              <a:ext cx="812934" cy="3766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0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F5A262B3-4657-4113-A5A8-274CE9F676D8}"/>
                </a:ext>
              </a:extLst>
            </p:cNvPr>
            <p:cNvSpPr txBox="1"/>
            <p:nvPr/>
          </p:nvSpPr>
          <p:spPr>
            <a:xfrm>
              <a:off x="1017456" y="2912794"/>
              <a:ext cx="812934" cy="3766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15’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D6BA98F5-97B1-4815-9DE7-C199545ACCF9}"/>
                </a:ext>
              </a:extLst>
            </p:cNvPr>
            <p:cNvSpPr txBox="1"/>
            <p:nvPr/>
          </p:nvSpPr>
          <p:spPr>
            <a:xfrm>
              <a:off x="1667207" y="2895710"/>
              <a:ext cx="812934" cy="3766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30’</a:t>
              </a:r>
            </a:p>
          </p:txBody>
        </p:sp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E7A6C3B9-9E77-4464-BE6D-1044CBD0AD6D}"/>
                </a:ext>
              </a:extLst>
            </p:cNvPr>
            <p:cNvCxnSpPr>
              <a:cxnSpLocks/>
            </p:cNvCxnSpPr>
            <p:nvPr/>
          </p:nvCxnSpPr>
          <p:spPr>
            <a:xfrm>
              <a:off x="170686" y="2903643"/>
              <a:ext cx="1902988" cy="7463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6E5E25C4-698B-4836-A6E2-80B36A081EDA}"/>
                </a:ext>
              </a:extLst>
            </p:cNvPr>
            <p:cNvSpPr txBox="1"/>
            <p:nvPr/>
          </p:nvSpPr>
          <p:spPr>
            <a:xfrm>
              <a:off x="910118" y="2621302"/>
              <a:ext cx="1431744" cy="3766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WT</a:t>
              </a:r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02C35C7B-20AC-428E-90EB-9D505E62E0E2}"/>
              </a:ext>
            </a:extLst>
          </p:cNvPr>
          <p:cNvGrpSpPr/>
          <p:nvPr/>
        </p:nvGrpSpPr>
        <p:grpSpPr>
          <a:xfrm>
            <a:off x="3275620" y="2760872"/>
            <a:ext cx="1729209" cy="637144"/>
            <a:chOff x="170686" y="2621302"/>
            <a:chExt cx="2171176" cy="637144"/>
          </a:xfrm>
        </p:grpSpPr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9E3F82DA-DAE0-45AC-AB90-FD98D88287D3}"/>
                </a:ext>
              </a:extLst>
            </p:cNvPr>
            <p:cNvSpPr txBox="1"/>
            <p:nvPr/>
          </p:nvSpPr>
          <p:spPr>
            <a:xfrm>
              <a:off x="226830" y="2881810"/>
              <a:ext cx="812934" cy="3766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0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B4C11DD9-E529-4241-B5C2-CDCF23481240}"/>
                </a:ext>
              </a:extLst>
            </p:cNvPr>
            <p:cNvSpPr txBox="1"/>
            <p:nvPr/>
          </p:nvSpPr>
          <p:spPr>
            <a:xfrm>
              <a:off x="873412" y="2864726"/>
              <a:ext cx="812934" cy="3766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15’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610989FC-32A5-460B-9F2E-3C7E9079DC17}"/>
                </a:ext>
              </a:extLst>
            </p:cNvPr>
            <p:cNvSpPr txBox="1"/>
            <p:nvPr/>
          </p:nvSpPr>
          <p:spPr>
            <a:xfrm>
              <a:off x="1521714" y="2880325"/>
              <a:ext cx="812934" cy="3766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30’</a:t>
              </a:r>
            </a:p>
          </p:txBody>
        </p: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70289E97-807B-4496-A25E-2AA40ACD8341}"/>
                </a:ext>
              </a:extLst>
            </p:cNvPr>
            <p:cNvCxnSpPr>
              <a:cxnSpLocks/>
            </p:cNvCxnSpPr>
            <p:nvPr/>
          </p:nvCxnSpPr>
          <p:spPr>
            <a:xfrm>
              <a:off x="170686" y="2903643"/>
              <a:ext cx="1902988" cy="7463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9988E220-AAD3-495E-81AB-0A5BB88AAF65}"/>
                </a:ext>
              </a:extLst>
            </p:cNvPr>
            <p:cNvSpPr txBox="1"/>
            <p:nvPr/>
          </p:nvSpPr>
          <p:spPr>
            <a:xfrm>
              <a:off x="910118" y="2621302"/>
              <a:ext cx="1431744" cy="3766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KO</a:t>
              </a:r>
            </a:p>
          </p:txBody>
        </p:sp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BED144AB-26B2-4302-A208-80D993965ABB}"/>
              </a:ext>
            </a:extLst>
          </p:cNvPr>
          <p:cNvGrpSpPr/>
          <p:nvPr/>
        </p:nvGrpSpPr>
        <p:grpSpPr>
          <a:xfrm>
            <a:off x="6715381" y="2743788"/>
            <a:ext cx="1839340" cy="651044"/>
            <a:chOff x="170686" y="2621302"/>
            <a:chExt cx="2309455" cy="651044"/>
          </a:xfrm>
        </p:grpSpPr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A6A8BE67-FF38-4972-8B25-456A15BCF07C}"/>
                </a:ext>
              </a:extLst>
            </p:cNvPr>
            <p:cNvSpPr txBox="1"/>
            <p:nvPr/>
          </p:nvSpPr>
          <p:spPr>
            <a:xfrm>
              <a:off x="226830" y="2881810"/>
              <a:ext cx="812934" cy="3766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0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E40C4E4E-1600-450D-8AFE-669C911D2374}"/>
                </a:ext>
              </a:extLst>
            </p:cNvPr>
            <p:cNvSpPr txBox="1"/>
            <p:nvPr/>
          </p:nvSpPr>
          <p:spPr>
            <a:xfrm>
              <a:off x="953995" y="2889093"/>
              <a:ext cx="812934" cy="3766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15’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76C3D801-4B5D-4130-B752-5263CA717924}"/>
                </a:ext>
              </a:extLst>
            </p:cNvPr>
            <p:cNvSpPr txBox="1"/>
            <p:nvPr/>
          </p:nvSpPr>
          <p:spPr>
            <a:xfrm>
              <a:off x="1667207" y="2895710"/>
              <a:ext cx="812934" cy="3766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30’</a:t>
              </a:r>
            </a:p>
          </p:txBody>
        </p:sp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id="{EE43194C-2581-449D-951F-123091C89528}"/>
                </a:ext>
              </a:extLst>
            </p:cNvPr>
            <p:cNvCxnSpPr>
              <a:cxnSpLocks/>
            </p:cNvCxnSpPr>
            <p:nvPr/>
          </p:nvCxnSpPr>
          <p:spPr>
            <a:xfrm>
              <a:off x="170686" y="2903643"/>
              <a:ext cx="1902988" cy="7463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3430E584-1B3A-44E1-93EE-8BDDD81D2BDC}"/>
                </a:ext>
              </a:extLst>
            </p:cNvPr>
            <p:cNvSpPr txBox="1"/>
            <p:nvPr/>
          </p:nvSpPr>
          <p:spPr>
            <a:xfrm>
              <a:off x="910118" y="2621302"/>
              <a:ext cx="1431744" cy="3766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WT</a:t>
              </a:r>
            </a:p>
          </p:txBody>
        </p:sp>
      </p:grpSp>
      <p:grpSp>
        <p:nvGrpSpPr>
          <p:cNvPr id="28" name="Group 27">
            <a:extLst>
              <a:ext uri="{FF2B5EF4-FFF2-40B4-BE49-F238E27FC236}">
                <a16:creationId xmlns:a16="http://schemas.microsoft.com/office/drawing/2014/main" id="{B9CAEE1D-E567-4254-A6AF-AAAC7910A1CD}"/>
              </a:ext>
            </a:extLst>
          </p:cNvPr>
          <p:cNvGrpSpPr/>
          <p:nvPr/>
        </p:nvGrpSpPr>
        <p:grpSpPr>
          <a:xfrm>
            <a:off x="8444590" y="2743788"/>
            <a:ext cx="1729209" cy="651044"/>
            <a:chOff x="170686" y="2621302"/>
            <a:chExt cx="2171176" cy="651044"/>
          </a:xfrm>
        </p:grpSpPr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061D4EA2-319E-4587-952D-1F4CFEF5A532}"/>
                </a:ext>
              </a:extLst>
            </p:cNvPr>
            <p:cNvSpPr txBox="1"/>
            <p:nvPr/>
          </p:nvSpPr>
          <p:spPr>
            <a:xfrm>
              <a:off x="226830" y="2881810"/>
              <a:ext cx="812934" cy="3766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0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24A390AE-CE05-47E5-AB5D-30B6DECB0447}"/>
                </a:ext>
              </a:extLst>
            </p:cNvPr>
            <p:cNvSpPr txBox="1"/>
            <p:nvPr/>
          </p:nvSpPr>
          <p:spPr>
            <a:xfrm>
              <a:off x="776051" y="2870586"/>
              <a:ext cx="812934" cy="3766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15’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7D4F18D5-CD5D-44D2-A0CA-197756359D96}"/>
                </a:ext>
              </a:extLst>
            </p:cNvPr>
            <p:cNvSpPr txBox="1"/>
            <p:nvPr/>
          </p:nvSpPr>
          <p:spPr>
            <a:xfrm>
              <a:off x="1487332" y="2895710"/>
              <a:ext cx="812934" cy="3766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30’</a:t>
              </a:r>
            </a:p>
          </p:txBody>
        </p: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F7AD7C71-858A-4AC1-A932-4015E939B98D}"/>
                </a:ext>
              </a:extLst>
            </p:cNvPr>
            <p:cNvCxnSpPr>
              <a:cxnSpLocks/>
            </p:cNvCxnSpPr>
            <p:nvPr/>
          </p:nvCxnSpPr>
          <p:spPr>
            <a:xfrm>
              <a:off x="170686" y="2903643"/>
              <a:ext cx="1902988" cy="7463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64CDF1B1-044F-4D6C-BD2C-0F12A0976961}"/>
                </a:ext>
              </a:extLst>
            </p:cNvPr>
            <p:cNvSpPr txBox="1"/>
            <p:nvPr/>
          </p:nvSpPr>
          <p:spPr>
            <a:xfrm>
              <a:off x="910118" y="2621302"/>
              <a:ext cx="1431744" cy="3766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KO</a:t>
              </a:r>
            </a:p>
          </p:txBody>
        </p:sp>
      </p:grpSp>
      <p:sp>
        <p:nvSpPr>
          <p:cNvPr id="34" name="Rectangle 33">
            <a:extLst>
              <a:ext uri="{FF2B5EF4-FFF2-40B4-BE49-F238E27FC236}">
                <a16:creationId xmlns:a16="http://schemas.microsoft.com/office/drawing/2014/main" id="{E9037DD1-00FD-425F-9BFD-F4D6683AA93F}"/>
              </a:ext>
            </a:extLst>
          </p:cNvPr>
          <p:cNvSpPr/>
          <p:nvPr/>
        </p:nvSpPr>
        <p:spPr>
          <a:xfrm>
            <a:off x="1546411" y="2743788"/>
            <a:ext cx="1140297" cy="171915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0C9958D3-D494-4C06-9212-42AC3095EF21}"/>
              </a:ext>
            </a:extLst>
          </p:cNvPr>
          <p:cNvSpPr/>
          <p:nvPr/>
        </p:nvSpPr>
        <p:spPr>
          <a:xfrm>
            <a:off x="3191547" y="2723103"/>
            <a:ext cx="1082200" cy="171915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42DF7C42-B610-43C8-8D19-3E661EEF7FFC}"/>
              </a:ext>
            </a:extLst>
          </p:cNvPr>
          <p:cNvSpPr/>
          <p:nvPr/>
        </p:nvSpPr>
        <p:spPr>
          <a:xfrm>
            <a:off x="6740836" y="2586506"/>
            <a:ext cx="1082200" cy="171915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36E61691-0840-4A36-8090-F2E97AC35C54}"/>
              </a:ext>
            </a:extLst>
          </p:cNvPr>
          <p:cNvSpPr/>
          <p:nvPr/>
        </p:nvSpPr>
        <p:spPr>
          <a:xfrm>
            <a:off x="8333134" y="2708891"/>
            <a:ext cx="1082200" cy="171915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B3890F3E-60AE-40E5-8103-74F73C51B481}"/>
              </a:ext>
            </a:extLst>
          </p:cNvPr>
          <p:cNvSpPr txBox="1"/>
          <p:nvPr/>
        </p:nvSpPr>
        <p:spPr>
          <a:xfrm>
            <a:off x="238452" y="73249"/>
            <a:ext cx="3352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Red Boxes were use in our data shown</a:t>
            </a:r>
          </a:p>
        </p:txBody>
      </p:sp>
    </p:spTree>
    <p:extLst>
      <p:ext uri="{BB962C8B-B14F-4D97-AF65-F5344CB8AC3E}">
        <p14:creationId xmlns:p14="http://schemas.microsoft.com/office/powerpoint/2010/main" val="13609306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CACD2855-A3FE-4B71-A00F-F230C8EC00A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80094" y="1376643"/>
            <a:ext cx="4831416" cy="4651642"/>
          </a:xfrm>
          <a:prstGeom prst="rect">
            <a:avLst/>
          </a:prstGeom>
        </p:spPr>
      </p:pic>
      <p:grpSp>
        <p:nvGrpSpPr>
          <p:cNvPr id="8" name="Group 7">
            <a:extLst>
              <a:ext uri="{FF2B5EF4-FFF2-40B4-BE49-F238E27FC236}">
                <a16:creationId xmlns:a16="http://schemas.microsoft.com/office/drawing/2014/main" id="{6CACEA74-1705-4039-B0E4-E1D51D193B78}"/>
              </a:ext>
            </a:extLst>
          </p:cNvPr>
          <p:cNvGrpSpPr/>
          <p:nvPr/>
        </p:nvGrpSpPr>
        <p:grpSpPr>
          <a:xfrm>
            <a:off x="7427121" y="2459045"/>
            <a:ext cx="1320884" cy="725118"/>
            <a:chOff x="457290" y="2596828"/>
            <a:chExt cx="1658486" cy="725118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51887E1-FCD9-45ED-82DB-2E66257D2F10}"/>
                </a:ext>
              </a:extLst>
            </p:cNvPr>
            <p:cNvSpPr txBox="1"/>
            <p:nvPr/>
          </p:nvSpPr>
          <p:spPr>
            <a:xfrm>
              <a:off x="497309" y="2945310"/>
              <a:ext cx="812935" cy="3766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0’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17EAB557-B3EF-4050-862C-95F8D1972620}"/>
                </a:ext>
              </a:extLst>
            </p:cNvPr>
            <p:cNvSpPr txBox="1"/>
            <p:nvPr/>
          </p:nvSpPr>
          <p:spPr>
            <a:xfrm>
              <a:off x="1017456" y="2912794"/>
              <a:ext cx="812934" cy="3766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15’</a:t>
              </a:r>
            </a:p>
          </p:txBody>
        </p: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A3A59ABF-F0F4-4805-8E2B-CE100AB9F05F}"/>
                </a:ext>
              </a:extLst>
            </p:cNvPr>
            <p:cNvCxnSpPr>
              <a:cxnSpLocks/>
            </p:cNvCxnSpPr>
            <p:nvPr/>
          </p:nvCxnSpPr>
          <p:spPr>
            <a:xfrm>
              <a:off x="457290" y="2945310"/>
              <a:ext cx="1069052" cy="21833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3E964314-F547-4FD3-BDE2-54BB13165E4E}"/>
                </a:ext>
              </a:extLst>
            </p:cNvPr>
            <p:cNvSpPr txBox="1"/>
            <p:nvPr/>
          </p:nvSpPr>
          <p:spPr>
            <a:xfrm>
              <a:off x="684032" y="2596828"/>
              <a:ext cx="1431744" cy="3766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WT</a:t>
              </a:r>
            </a:p>
          </p:txBody>
        </p:sp>
      </p:grpSp>
      <p:sp>
        <p:nvSpPr>
          <p:cNvPr id="14" name="Rectangle 13">
            <a:extLst>
              <a:ext uri="{FF2B5EF4-FFF2-40B4-BE49-F238E27FC236}">
                <a16:creationId xmlns:a16="http://schemas.microsoft.com/office/drawing/2014/main" id="{28FBD571-74E9-46B4-978E-C278826CB8D6}"/>
              </a:ext>
            </a:extLst>
          </p:cNvPr>
          <p:cNvSpPr/>
          <p:nvPr/>
        </p:nvSpPr>
        <p:spPr>
          <a:xfrm>
            <a:off x="7289783" y="3169416"/>
            <a:ext cx="2153534" cy="171915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F9B6A5D-BB42-45A8-95EC-464877339412}"/>
              </a:ext>
            </a:extLst>
          </p:cNvPr>
          <p:cNvSpPr txBox="1"/>
          <p:nvPr/>
        </p:nvSpPr>
        <p:spPr>
          <a:xfrm>
            <a:off x="6245866" y="3128101"/>
            <a:ext cx="1285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ctin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B498246-5AA0-42FF-9EF3-A33F04A14D0A}"/>
              </a:ext>
            </a:extLst>
          </p:cNvPr>
          <p:cNvSpPr txBox="1"/>
          <p:nvPr/>
        </p:nvSpPr>
        <p:spPr>
          <a:xfrm>
            <a:off x="6247360" y="3771808"/>
            <a:ext cx="1285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-p65</a:t>
            </a: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5B650F19-2504-41A0-A0D9-863043826B14}"/>
              </a:ext>
            </a:extLst>
          </p:cNvPr>
          <p:cNvGrpSpPr/>
          <p:nvPr/>
        </p:nvGrpSpPr>
        <p:grpSpPr>
          <a:xfrm>
            <a:off x="8424279" y="2537484"/>
            <a:ext cx="1432985" cy="680685"/>
            <a:chOff x="226830" y="2608745"/>
            <a:chExt cx="1799239" cy="680685"/>
          </a:xfrm>
        </p:grpSpPr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9D39B305-5983-49B5-B44C-B58CD89B7296}"/>
                </a:ext>
              </a:extLst>
            </p:cNvPr>
            <p:cNvSpPr txBox="1"/>
            <p:nvPr/>
          </p:nvSpPr>
          <p:spPr>
            <a:xfrm>
              <a:off x="226830" y="2881810"/>
              <a:ext cx="812934" cy="3766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0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9BDCB4E3-BCD8-493F-ACB3-EA22C593E065}"/>
                </a:ext>
              </a:extLst>
            </p:cNvPr>
            <p:cNvSpPr txBox="1"/>
            <p:nvPr/>
          </p:nvSpPr>
          <p:spPr>
            <a:xfrm>
              <a:off x="1017456" y="2912794"/>
              <a:ext cx="812934" cy="3766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15’</a:t>
              </a:r>
            </a:p>
          </p:txBody>
        </p: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7F13A684-4ABA-4580-BE96-9420CB8F13DC}"/>
                </a:ext>
              </a:extLst>
            </p:cNvPr>
            <p:cNvCxnSpPr>
              <a:cxnSpLocks/>
            </p:cNvCxnSpPr>
            <p:nvPr/>
          </p:nvCxnSpPr>
          <p:spPr>
            <a:xfrm>
              <a:off x="425660" y="2892726"/>
              <a:ext cx="1080661" cy="11183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25827747-9DF3-4D29-9D3E-71EA68886F5A}"/>
                </a:ext>
              </a:extLst>
            </p:cNvPr>
            <p:cNvSpPr txBox="1"/>
            <p:nvPr/>
          </p:nvSpPr>
          <p:spPr>
            <a:xfrm>
              <a:off x="594324" y="2608745"/>
              <a:ext cx="1431745" cy="3766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KO</a:t>
              </a:r>
            </a:p>
          </p:txBody>
        </p:sp>
      </p:grpSp>
      <p:grpSp>
        <p:nvGrpSpPr>
          <p:cNvPr id="26" name="Group 25">
            <a:extLst>
              <a:ext uri="{FF2B5EF4-FFF2-40B4-BE49-F238E27FC236}">
                <a16:creationId xmlns:a16="http://schemas.microsoft.com/office/drawing/2014/main" id="{8E605ADC-1D8E-4AB7-9576-D9F705BEC648}"/>
              </a:ext>
            </a:extLst>
          </p:cNvPr>
          <p:cNvGrpSpPr/>
          <p:nvPr/>
        </p:nvGrpSpPr>
        <p:grpSpPr>
          <a:xfrm>
            <a:off x="9552072" y="2537357"/>
            <a:ext cx="1039001" cy="677790"/>
            <a:chOff x="464878" y="2611640"/>
            <a:chExt cx="1528806" cy="677790"/>
          </a:xfrm>
        </p:grpSpPr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80FC65BA-8F6D-4001-8875-7B87464D0B28}"/>
                </a:ext>
              </a:extLst>
            </p:cNvPr>
            <p:cNvSpPr txBox="1"/>
            <p:nvPr/>
          </p:nvSpPr>
          <p:spPr>
            <a:xfrm>
              <a:off x="464878" y="2895748"/>
              <a:ext cx="812934" cy="3766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0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4FD5E694-CD44-4AF5-9D07-2A1F6D09D8F7}"/>
                </a:ext>
              </a:extLst>
            </p:cNvPr>
            <p:cNvSpPr txBox="1"/>
            <p:nvPr/>
          </p:nvSpPr>
          <p:spPr>
            <a:xfrm>
              <a:off x="1017456" y="2912794"/>
              <a:ext cx="812934" cy="3766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15’</a:t>
              </a:r>
            </a:p>
          </p:txBody>
        </p: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F0D38E0B-553E-4FDF-B33E-B728D95CFB8D}"/>
                </a:ext>
              </a:extLst>
            </p:cNvPr>
            <p:cNvCxnSpPr>
              <a:cxnSpLocks/>
            </p:cNvCxnSpPr>
            <p:nvPr/>
          </p:nvCxnSpPr>
          <p:spPr>
            <a:xfrm>
              <a:off x="552510" y="2908729"/>
              <a:ext cx="1069052" cy="21834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33AA990E-9983-400D-8762-34CAE50796A7}"/>
                </a:ext>
              </a:extLst>
            </p:cNvPr>
            <p:cNvSpPr txBox="1"/>
            <p:nvPr/>
          </p:nvSpPr>
          <p:spPr>
            <a:xfrm>
              <a:off x="561939" y="2611640"/>
              <a:ext cx="1431745" cy="3766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WT</a:t>
              </a:r>
            </a:p>
          </p:txBody>
        </p:sp>
      </p:grpSp>
      <p:grpSp>
        <p:nvGrpSpPr>
          <p:cNvPr id="31" name="Group 30">
            <a:extLst>
              <a:ext uri="{FF2B5EF4-FFF2-40B4-BE49-F238E27FC236}">
                <a16:creationId xmlns:a16="http://schemas.microsoft.com/office/drawing/2014/main" id="{59ACBF72-FEE1-4925-BF10-45CFF63F88A2}"/>
              </a:ext>
            </a:extLst>
          </p:cNvPr>
          <p:cNvGrpSpPr/>
          <p:nvPr/>
        </p:nvGrpSpPr>
        <p:grpSpPr>
          <a:xfrm>
            <a:off x="10419993" y="2552231"/>
            <a:ext cx="1173137" cy="680685"/>
            <a:chOff x="226830" y="2608745"/>
            <a:chExt cx="1799239" cy="680685"/>
          </a:xfrm>
        </p:grpSpPr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F7130B56-10BD-42F5-BDDE-D9BB9C37C8D7}"/>
                </a:ext>
              </a:extLst>
            </p:cNvPr>
            <p:cNvSpPr txBox="1"/>
            <p:nvPr/>
          </p:nvSpPr>
          <p:spPr>
            <a:xfrm>
              <a:off x="226830" y="2881810"/>
              <a:ext cx="812934" cy="3766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0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7A73F3C2-8CDF-4D95-BA4E-548E2EB31D2F}"/>
                </a:ext>
              </a:extLst>
            </p:cNvPr>
            <p:cNvSpPr txBox="1"/>
            <p:nvPr/>
          </p:nvSpPr>
          <p:spPr>
            <a:xfrm>
              <a:off x="1017456" y="2912794"/>
              <a:ext cx="812934" cy="3766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15’</a:t>
              </a:r>
            </a:p>
          </p:txBody>
        </p:sp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B87B3FD6-7AB5-434D-B2B4-377ECE118F8D}"/>
                </a:ext>
              </a:extLst>
            </p:cNvPr>
            <p:cNvCxnSpPr>
              <a:cxnSpLocks/>
            </p:cNvCxnSpPr>
            <p:nvPr/>
          </p:nvCxnSpPr>
          <p:spPr>
            <a:xfrm>
              <a:off x="425660" y="2892726"/>
              <a:ext cx="1080661" cy="11183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5069C8D0-ACBA-4861-A5E6-AC0CED4F479C}"/>
                </a:ext>
              </a:extLst>
            </p:cNvPr>
            <p:cNvSpPr txBox="1"/>
            <p:nvPr/>
          </p:nvSpPr>
          <p:spPr>
            <a:xfrm>
              <a:off x="594324" y="2608745"/>
              <a:ext cx="1431745" cy="3766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KO</a:t>
              </a:r>
            </a:p>
          </p:txBody>
        </p:sp>
      </p:grpSp>
      <p:sp>
        <p:nvSpPr>
          <p:cNvPr id="36" name="TextBox 35">
            <a:extLst>
              <a:ext uri="{FF2B5EF4-FFF2-40B4-BE49-F238E27FC236}">
                <a16:creationId xmlns:a16="http://schemas.microsoft.com/office/drawing/2014/main" id="{4B8D1A1A-2EFD-4E43-BF10-79122E6A935D}"/>
              </a:ext>
            </a:extLst>
          </p:cNvPr>
          <p:cNvSpPr txBox="1"/>
          <p:nvPr/>
        </p:nvSpPr>
        <p:spPr>
          <a:xfrm>
            <a:off x="10419993" y="4412458"/>
            <a:ext cx="150015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Membrane was cut off and we did not use these</a:t>
            </a:r>
          </a:p>
        </p:txBody>
      </p: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19667D5C-63AA-4A89-A26C-5CB7E059867F}"/>
              </a:ext>
            </a:extLst>
          </p:cNvPr>
          <p:cNvCxnSpPr>
            <a:cxnSpLocks/>
          </p:cNvCxnSpPr>
          <p:nvPr/>
        </p:nvCxnSpPr>
        <p:spPr>
          <a:xfrm flipH="1" flipV="1">
            <a:off x="11078043" y="4135956"/>
            <a:ext cx="152400" cy="35941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CE95F0F9-9655-4795-919D-79044ADFCE19}"/>
              </a:ext>
            </a:extLst>
          </p:cNvPr>
          <p:cNvCxnSpPr>
            <a:cxnSpLocks/>
          </p:cNvCxnSpPr>
          <p:nvPr/>
        </p:nvCxnSpPr>
        <p:spPr>
          <a:xfrm flipH="1" flipV="1">
            <a:off x="11126368" y="3417582"/>
            <a:ext cx="104075" cy="107778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57119D18-1A8B-4DAC-A76C-FB6F481A4D72}"/>
              </a:ext>
            </a:extLst>
          </p:cNvPr>
          <p:cNvSpPr txBox="1"/>
          <p:nvPr/>
        </p:nvSpPr>
        <p:spPr>
          <a:xfrm>
            <a:off x="238452" y="73249"/>
            <a:ext cx="3352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Red box outlines lanes used for the data shown </a:t>
            </a:r>
            <a:r>
              <a:rPr lang="en-US">
                <a:solidFill>
                  <a:srgbClr val="FF0000"/>
                </a:solidFill>
              </a:rPr>
              <a:t>in Figure 6</a:t>
            </a:r>
            <a:endParaRPr lang="en-US" dirty="0">
              <a:solidFill>
                <a:srgbClr val="FF0000"/>
              </a:solidFill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89F7FF75-D68E-423D-A315-9032A6EF95DB}"/>
              </a:ext>
            </a:extLst>
          </p:cNvPr>
          <p:cNvSpPr txBox="1"/>
          <p:nvPr/>
        </p:nvSpPr>
        <p:spPr>
          <a:xfrm>
            <a:off x="2948700" y="911342"/>
            <a:ext cx="1285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xp #3</a:t>
            </a:r>
          </a:p>
        </p:txBody>
      </p:sp>
      <p:pic>
        <p:nvPicPr>
          <p:cNvPr id="44" name="Picture 43">
            <a:extLst>
              <a:ext uri="{FF2B5EF4-FFF2-40B4-BE49-F238E27FC236}">
                <a16:creationId xmlns:a16="http://schemas.microsoft.com/office/drawing/2014/main" id="{867D5BDE-68EC-4C62-9482-89BCF17F2CF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61558" y="1403044"/>
            <a:ext cx="4740680" cy="4879094"/>
          </a:xfrm>
          <a:prstGeom prst="rect">
            <a:avLst/>
          </a:prstGeom>
        </p:spPr>
      </p:pic>
      <p:sp>
        <p:nvSpPr>
          <p:cNvPr id="45" name="TextBox 44">
            <a:extLst>
              <a:ext uri="{FF2B5EF4-FFF2-40B4-BE49-F238E27FC236}">
                <a16:creationId xmlns:a16="http://schemas.microsoft.com/office/drawing/2014/main" id="{08D62779-6882-4FC8-BA75-0697E2ECADAF}"/>
              </a:ext>
            </a:extLst>
          </p:cNvPr>
          <p:cNvSpPr txBox="1"/>
          <p:nvPr/>
        </p:nvSpPr>
        <p:spPr>
          <a:xfrm>
            <a:off x="8953164" y="1096008"/>
            <a:ext cx="1285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xp #4</a:t>
            </a:r>
          </a:p>
        </p:txBody>
      </p:sp>
      <p:grpSp>
        <p:nvGrpSpPr>
          <p:cNvPr id="46" name="Group 45">
            <a:extLst>
              <a:ext uri="{FF2B5EF4-FFF2-40B4-BE49-F238E27FC236}">
                <a16:creationId xmlns:a16="http://schemas.microsoft.com/office/drawing/2014/main" id="{0CACF9A9-DD8D-4460-95F5-85109F96C523}"/>
              </a:ext>
            </a:extLst>
          </p:cNvPr>
          <p:cNvGrpSpPr/>
          <p:nvPr/>
        </p:nvGrpSpPr>
        <p:grpSpPr>
          <a:xfrm>
            <a:off x="2108075" y="3087134"/>
            <a:ext cx="1887374" cy="793597"/>
            <a:chOff x="367793" y="2636409"/>
            <a:chExt cx="2369764" cy="793597"/>
          </a:xfrm>
        </p:grpSpPr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EC188C48-2B95-4A3F-844F-3004D2AF0757}"/>
                </a:ext>
              </a:extLst>
            </p:cNvPr>
            <p:cNvSpPr txBox="1"/>
            <p:nvPr/>
          </p:nvSpPr>
          <p:spPr>
            <a:xfrm>
              <a:off x="594536" y="2689186"/>
              <a:ext cx="812934" cy="3766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0’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C9430487-D46E-4A47-B302-6E5737CC5CD9}"/>
                </a:ext>
              </a:extLst>
            </p:cNvPr>
            <p:cNvSpPr txBox="1"/>
            <p:nvPr/>
          </p:nvSpPr>
          <p:spPr>
            <a:xfrm>
              <a:off x="1924622" y="2636409"/>
              <a:ext cx="812935" cy="3766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15’</a:t>
              </a:r>
            </a:p>
          </p:txBody>
        </p:sp>
        <p:cxnSp>
          <p:nvCxnSpPr>
            <p:cNvPr id="49" name="Straight Connector 48">
              <a:extLst>
                <a:ext uri="{FF2B5EF4-FFF2-40B4-BE49-F238E27FC236}">
                  <a16:creationId xmlns:a16="http://schemas.microsoft.com/office/drawing/2014/main" id="{C936C653-B229-4E30-82A5-0E0436C893A9}"/>
                </a:ext>
              </a:extLst>
            </p:cNvPr>
            <p:cNvCxnSpPr>
              <a:cxnSpLocks/>
            </p:cNvCxnSpPr>
            <p:nvPr/>
          </p:nvCxnSpPr>
          <p:spPr>
            <a:xfrm>
              <a:off x="429735" y="3071862"/>
              <a:ext cx="1069052" cy="21833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5F0CE0E0-ED44-4C25-A69D-A8D4D1B6528F}"/>
                </a:ext>
              </a:extLst>
            </p:cNvPr>
            <p:cNvSpPr txBox="1"/>
            <p:nvPr/>
          </p:nvSpPr>
          <p:spPr>
            <a:xfrm>
              <a:off x="367793" y="3053370"/>
              <a:ext cx="1431744" cy="3766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WT</a:t>
              </a:r>
            </a:p>
          </p:txBody>
        </p:sp>
      </p:grpSp>
      <p:sp>
        <p:nvSpPr>
          <p:cNvPr id="57" name="TextBox 56">
            <a:extLst>
              <a:ext uri="{FF2B5EF4-FFF2-40B4-BE49-F238E27FC236}">
                <a16:creationId xmlns:a16="http://schemas.microsoft.com/office/drawing/2014/main" id="{BDF5FDFA-EFC4-4806-94C0-3E4957214D82}"/>
              </a:ext>
            </a:extLst>
          </p:cNvPr>
          <p:cNvSpPr txBox="1"/>
          <p:nvPr/>
        </p:nvSpPr>
        <p:spPr>
          <a:xfrm>
            <a:off x="2613815" y="3465955"/>
            <a:ext cx="1140298" cy="3766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KO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EE612AD6-E0F1-431D-9859-D23E5A0293B7}"/>
              </a:ext>
            </a:extLst>
          </p:cNvPr>
          <p:cNvSpPr txBox="1"/>
          <p:nvPr/>
        </p:nvSpPr>
        <p:spPr>
          <a:xfrm>
            <a:off x="3139515" y="3544420"/>
            <a:ext cx="1140298" cy="3766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WT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D58D180A-DAD2-4A10-B435-4A428345A6AE}"/>
              </a:ext>
            </a:extLst>
          </p:cNvPr>
          <p:cNvSpPr txBox="1"/>
          <p:nvPr/>
        </p:nvSpPr>
        <p:spPr>
          <a:xfrm>
            <a:off x="4692612" y="3579838"/>
            <a:ext cx="1140298" cy="3766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KO</a:t>
            </a:r>
          </a:p>
        </p:txBody>
      </p: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916447EF-B775-473A-86B0-0D3DA6F4C3B9}"/>
              </a:ext>
            </a:extLst>
          </p:cNvPr>
          <p:cNvCxnSpPr>
            <a:cxnSpLocks/>
          </p:cNvCxnSpPr>
          <p:nvPr/>
        </p:nvCxnSpPr>
        <p:spPr>
          <a:xfrm>
            <a:off x="3244809" y="3536633"/>
            <a:ext cx="851435" cy="2183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id="{BE54FB1E-A118-49DB-AD3C-B8B20F7180D1}"/>
              </a:ext>
            </a:extLst>
          </p:cNvPr>
          <p:cNvSpPr txBox="1"/>
          <p:nvPr/>
        </p:nvSpPr>
        <p:spPr>
          <a:xfrm>
            <a:off x="3616629" y="3533503"/>
            <a:ext cx="1140298" cy="3766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KO</a:t>
            </a:r>
          </a:p>
        </p:txBody>
      </p: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839EDA0E-565F-4B63-9C21-0C2CAF9B1AA0}"/>
              </a:ext>
            </a:extLst>
          </p:cNvPr>
          <p:cNvCxnSpPr>
            <a:cxnSpLocks/>
          </p:cNvCxnSpPr>
          <p:nvPr/>
        </p:nvCxnSpPr>
        <p:spPr>
          <a:xfrm>
            <a:off x="4328138" y="3548166"/>
            <a:ext cx="851435" cy="2183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>
            <a:extLst>
              <a:ext uri="{FF2B5EF4-FFF2-40B4-BE49-F238E27FC236}">
                <a16:creationId xmlns:a16="http://schemas.microsoft.com/office/drawing/2014/main" id="{FC4C5E7A-5F05-4434-986D-CBEA4C1BE311}"/>
              </a:ext>
            </a:extLst>
          </p:cNvPr>
          <p:cNvSpPr txBox="1"/>
          <p:nvPr/>
        </p:nvSpPr>
        <p:spPr>
          <a:xfrm>
            <a:off x="4130638" y="3569999"/>
            <a:ext cx="1140298" cy="3766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WT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B4602817-A6AB-49BC-AD82-B35763E16263}"/>
              </a:ext>
            </a:extLst>
          </p:cNvPr>
          <p:cNvSpPr txBox="1"/>
          <p:nvPr/>
        </p:nvSpPr>
        <p:spPr>
          <a:xfrm>
            <a:off x="4549578" y="3099683"/>
            <a:ext cx="647454" cy="3766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30’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6CBFAC12-BD66-4D21-9DDD-EB036DD07318}"/>
              </a:ext>
            </a:extLst>
          </p:cNvPr>
          <p:cNvSpPr txBox="1"/>
          <p:nvPr/>
        </p:nvSpPr>
        <p:spPr>
          <a:xfrm>
            <a:off x="177519" y="3452061"/>
            <a:ext cx="1285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ctin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20A58CDB-2361-403D-9B6D-1D838726E8D0}"/>
              </a:ext>
            </a:extLst>
          </p:cNvPr>
          <p:cNvSpPr txBox="1"/>
          <p:nvPr/>
        </p:nvSpPr>
        <p:spPr>
          <a:xfrm>
            <a:off x="238452" y="4346619"/>
            <a:ext cx="1285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-p65</a:t>
            </a:r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5492A67C-D558-4C63-871D-D1DADB7589B6}"/>
              </a:ext>
            </a:extLst>
          </p:cNvPr>
          <p:cNvSpPr/>
          <p:nvPr/>
        </p:nvSpPr>
        <p:spPr>
          <a:xfrm>
            <a:off x="1918022" y="3044598"/>
            <a:ext cx="2153534" cy="171915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66190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0</TotalTime>
  <Words>101</Words>
  <Application>Microsoft Macintosh PowerPoint</Application>
  <PresentationFormat>Widescreen</PresentationFormat>
  <Paragraphs>5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ham, Hai (NIH/NIDCR) [F]</dc:creator>
  <cp:lastModifiedBy>Young, Marian (NIH/NIDCR) [E]</cp:lastModifiedBy>
  <cp:revision>10</cp:revision>
  <dcterms:created xsi:type="dcterms:W3CDTF">2019-07-03T18:30:39Z</dcterms:created>
  <dcterms:modified xsi:type="dcterms:W3CDTF">2020-07-15T18:14:17Z</dcterms:modified>
</cp:coreProperties>
</file>